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  <p:sldId id="267" r:id="rId3"/>
    <p:sldId id="26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2133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838A6-BE6C-408F-9312-8DB8EE4A202F}" type="datetimeFigureOut">
              <a:rPr lang="zh-CN" altLang="en-US" smtClean="0"/>
              <a:t>2019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FD561-FBF6-44AC-9739-358C896612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5585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838A6-BE6C-408F-9312-8DB8EE4A202F}" type="datetimeFigureOut">
              <a:rPr lang="zh-CN" altLang="en-US" smtClean="0"/>
              <a:t>2019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FD561-FBF6-44AC-9739-358C896612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502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838A6-BE6C-408F-9312-8DB8EE4A202F}" type="datetimeFigureOut">
              <a:rPr lang="zh-CN" altLang="en-US" smtClean="0"/>
              <a:t>2019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FD561-FBF6-44AC-9739-358C896612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02847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838A6-BE6C-408F-9312-8DB8EE4A202F}" type="datetimeFigureOut">
              <a:rPr lang="zh-CN" altLang="en-US" smtClean="0"/>
              <a:t>2019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FD561-FBF6-44AC-9739-358C896612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24222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838A6-BE6C-408F-9312-8DB8EE4A202F}" type="datetimeFigureOut">
              <a:rPr lang="zh-CN" altLang="en-US" smtClean="0"/>
              <a:t>2019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FD561-FBF6-44AC-9739-358C896612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27696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838A6-BE6C-408F-9312-8DB8EE4A202F}" type="datetimeFigureOut">
              <a:rPr lang="zh-CN" altLang="en-US" smtClean="0"/>
              <a:t>2019/7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FD561-FBF6-44AC-9739-358C896612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7172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838A6-BE6C-408F-9312-8DB8EE4A202F}" type="datetimeFigureOut">
              <a:rPr lang="zh-CN" altLang="en-US" smtClean="0"/>
              <a:t>2019/7/1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FD561-FBF6-44AC-9739-358C896612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4536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838A6-BE6C-408F-9312-8DB8EE4A202F}" type="datetimeFigureOut">
              <a:rPr lang="zh-CN" altLang="en-US" smtClean="0"/>
              <a:t>2019/7/1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FD561-FBF6-44AC-9739-358C896612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79350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838A6-BE6C-408F-9312-8DB8EE4A202F}" type="datetimeFigureOut">
              <a:rPr lang="zh-CN" altLang="en-US" smtClean="0"/>
              <a:t>2019/7/1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FD561-FBF6-44AC-9739-358C896612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40552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838A6-BE6C-408F-9312-8DB8EE4A202F}" type="datetimeFigureOut">
              <a:rPr lang="zh-CN" altLang="en-US" smtClean="0"/>
              <a:t>2019/7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FD561-FBF6-44AC-9739-358C896612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3853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838A6-BE6C-408F-9312-8DB8EE4A202F}" type="datetimeFigureOut">
              <a:rPr lang="zh-CN" altLang="en-US" smtClean="0"/>
              <a:t>2019/7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FD561-FBF6-44AC-9739-358C896612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32486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3838A6-BE6C-408F-9312-8DB8EE4A202F}" type="datetimeFigureOut">
              <a:rPr lang="zh-CN" altLang="en-US" smtClean="0"/>
              <a:t>2019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7FD561-FBF6-44AC-9739-358C896612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73026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5EC2CF09-8101-49AD-A027-2EC1CA1BAF5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965" t="8563" r="2228" b="8029"/>
          <a:stretch/>
        </p:blipFill>
        <p:spPr>
          <a:xfrm>
            <a:off x="837825" y="2061975"/>
            <a:ext cx="2801005" cy="2098622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4CEA9965-C9FB-40BD-BED7-AC3C14FDB057}"/>
              </a:ext>
            </a:extLst>
          </p:cNvPr>
          <p:cNvSpPr txBox="1"/>
          <p:nvPr/>
        </p:nvSpPr>
        <p:spPr>
          <a:xfrm>
            <a:off x="713135" y="1893600"/>
            <a:ext cx="4337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02A0144D-9D28-4F22-A881-67A3B3AD439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1467" t="8562" r="1206" b="6598"/>
          <a:stretch/>
        </p:blipFill>
        <p:spPr>
          <a:xfrm>
            <a:off x="3638830" y="2055879"/>
            <a:ext cx="2783741" cy="2134657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C1DBE2BB-5F00-4118-BBD3-FCFCFBCF1D35}"/>
              </a:ext>
            </a:extLst>
          </p:cNvPr>
          <p:cNvSpPr txBox="1"/>
          <p:nvPr/>
        </p:nvSpPr>
        <p:spPr>
          <a:xfrm>
            <a:off x="1303634" y="1977910"/>
            <a:ext cx="13494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Up regulated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7B9AAE02-8651-4F22-9AFE-18D7BF1735B1}"/>
              </a:ext>
            </a:extLst>
          </p:cNvPr>
          <p:cNvSpPr txBox="1"/>
          <p:nvPr/>
        </p:nvSpPr>
        <p:spPr>
          <a:xfrm>
            <a:off x="4104639" y="1901941"/>
            <a:ext cx="13494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down regulated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7DEF1413-A89A-42A0-AE9D-A5B4C541186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9965" t="7943" r="4335" b="8360"/>
          <a:stretch/>
        </p:blipFill>
        <p:spPr>
          <a:xfrm>
            <a:off x="853590" y="4273208"/>
            <a:ext cx="2725182" cy="2098623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DC939EBA-757D-4ED5-A63F-BDBA20BC6D6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0091" t="7869" r="4209" b="5210"/>
          <a:stretch/>
        </p:blipFill>
        <p:spPr>
          <a:xfrm>
            <a:off x="3610775" y="4282968"/>
            <a:ext cx="2725182" cy="2175642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91FA40B5-72E8-46E4-A6F3-476349FE1FCA}"/>
              </a:ext>
            </a:extLst>
          </p:cNvPr>
          <p:cNvSpPr txBox="1"/>
          <p:nvPr/>
        </p:nvSpPr>
        <p:spPr>
          <a:xfrm>
            <a:off x="1227059" y="4156766"/>
            <a:ext cx="13494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Up regulated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86599084-1577-49E4-B3E4-AF47C5901E60}"/>
              </a:ext>
            </a:extLst>
          </p:cNvPr>
          <p:cNvSpPr txBox="1"/>
          <p:nvPr/>
        </p:nvSpPr>
        <p:spPr>
          <a:xfrm>
            <a:off x="3875666" y="4156766"/>
            <a:ext cx="13494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down regulated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2685299-BA92-49B2-83C2-093518AC6543}"/>
              </a:ext>
            </a:extLst>
          </p:cNvPr>
          <p:cNvSpPr txBox="1"/>
          <p:nvPr/>
        </p:nvSpPr>
        <p:spPr>
          <a:xfrm>
            <a:off x="712800" y="4105281"/>
            <a:ext cx="4337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C04A4AE6-C20B-4D61-B158-FACD59B22245}"/>
              </a:ext>
            </a:extLst>
          </p:cNvPr>
          <p:cNvSpPr txBox="1"/>
          <p:nvPr/>
        </p:nvSpPr>
        <p:spPr>
          <a:xfrm>
            <a:off x="865535" y="2017256"/>
            <a:ext cx="4337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A/C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318B20EF-EFAE-46EC-929F-6730A5E6E3D9}"/>
              </a:ext>
            </a:extLst>
          </p:cNvPr>
          <p:cNvSpPr txBox="1"/>
          <p:nvPr/>
        </p:nvSpPr>
        <p:spPr>
          <a:xfrm>
            <a:off x="853833" y="4252281"/>
            <a:ext cx="4337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B/C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1E12759-46D5-4EE8-921C-A9690EEF75AE}"/>
              </a:ext>
            </a:extLst>
          </p:cNvPr>
          <p:cNvSpPr txBox="1"/>
          <p:nvPr/>
        </p:nvSpPr>
        <p:spPr>
          <a:xfrm>
            <a:off x="2534478" y="1395468"/>
            <a:ext cx="1789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S.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EF230EEA-A05F-4515-9237-0EDDA5277C56}"/>
              </a:ext>
            </a:extLst>
          </p:cNvPr>
          <p:cNvSpPr txBox="1"/>
          <p:nvPr/>
        </p:nvSpPr>
        <p:spPr>
          <a:xfrm>
            <a:off x="3456187" y="1895154"/>
            <a:ext cx="4337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26940EC-D18A-4889-B8B4-0A39964FC918}"/>
              </a:ext>
            </a:extLst>
          </p:cNvPr>
          <p:cNvSpPr txBox="1"/>
          <p:nvPr/>
        </p:nvSpPr>
        <p:spPr>
          <a:xfrm>
            <a:off x="3456000" y="4104042"/>
            <a:ext cx="4337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2BD380FB-1A0E-4845-A6EA-3BB890E685C2}"/>
              </a:ext>
            </a:extLst>
          </p:cNvPr>
          <p:cNvSpPr/>
          <p:nvPr/>
        </p:nvSpPr>
        <p:spPr>
          <a:xfrm>
            <a:off x="837824" y="6441185"/>
            <a:ext cx="5651987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S.1 Cellular component of differentially expressed proteins associated with DF and DHF. </a:t>
            </a:r>
            <a:r>
              <a:rPr lang="en-US" altLang="zh-CN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Cellular component of up-regulated proteins in A/C. (B) Cellular component of down-regulated proteins in A/C. (C) Cellular component of up-regulated proteins in B/C. (D) Cellular component of down-regulated proteins in B/C.</a:t>
            </a:r>
            <a:endParaRPr lang="zh-CN" altLang="zh-CN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00731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>
            <a:extLst>
              <a:ext uri="{FF2B5EF4-FFF2-40B4-BE49-F238E27FC236}">
                <a16:creationId xmlns:a16="http://schemas.microsoft.com/office/drawing/2014/main" id="{5B3CC61B-AFC9-4549-BFDA-5C630BB5A0E9}"/>
              </a:ext>
            </a:extLst>
          </p:cNvPr>
          <p:cNvGrpSpPr/>
          <p:nvPr/>
        </p:nvGrpSpPr>
        <p:grpSpPr>
          <a:xfrm>
            <a:off x="1567543" y="1186168"/>
            <a:ext cx="3684628" cy="4768693"/>
            <a:chOff x="1567543" y="1186168"/>
            <a:chExt cx="3684628" cy="4768693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6F49EE73-0466-4B06-BAEF-57EE124AAB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8688" t="2706" r="10448" b="8932"/>
            <a:stretch/>
          </p:blipFill>
          <p:spPr>
            <a:xfrm>
              <a:off x="2184651" y="1186168"/>
              <a:ext cx="3067520" cy="2288252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3CA172D0-E714-4544-B5B2-747B03EADDD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5819" t="3750" r="11699" b="9974"/>
            <a:stretch/>
          </p:blipFill>
          <p:spPr>
            <a:xfrm>
              <a:off x="1567543" y="3720662"/>
              <a:ext cx="3653096" cy="2234199"/>
            </a:xfrm>
            <a:prstGeom prst="rect">
              <a:avLst/>
            </a:prstGeom>
          </p:spPr>
        </p:pic>
      </p:grpSp>
      <p:sp>
        <p:nvSpPr>
          <p:cNvPr id="10" name="文本框 9">
            <a:extLst>
              <a:ext uri="{FF2B5EF4-FFF2-40B4-BE49-F238E27FC236}">
                <a16:creationId xmlns:a16="http://schemas.microsoft.com/office/drawing/2014/main" id="{7FA546C8-BE9B-4CBD-8ED0-4DCD55278929}"/>
              </a:ext>
            </a:extLst>
          </p:cNvPr>
          <p:cNvSpPr txBox="1"/>
          <p:nvPr/>
        </p:nvSpPr>
        <p:spPr>
          <a:xfrm>
            <a:off x="1061648" y="1231863"/>
            <a:ext cx="13494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Up regulated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48C367E3-0031-49E4-9469-67C6630F251D}"/>
              </a:ext>
            </a:extLst>
          </p:cNvPr>
          <p:cNvSpPr txBox="1"/>
          <p:nvPr/>
        </p:nvSpPr>
        <p:spPr>
          <a:xfrm>
            <a:off x="1128879" y="3699445"/>
            <a:ext cx="13494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Down regulated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4254E351-41F4-49AB-9A0C-590289C22457}"/>
              </a:ext>
            </a:extLst>
          </p:cNvPr>
          <p:cNvSpPr txBox="1"/>
          <p:nvPr/>
        </p:nvSpPr>
        <p:spPr>
          <a:xfrm>
            <a:off x="2534477" y="610552"/>
            <a:ext cx="17890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FigS.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A2AE5879-A3C0-4862-9F6A-5C4BF704EBAE}"/>
              </a:ext>
            </a:extLst>
          </p:cNvPr>
          <p:cNvSpPr txBox="1"/>
          <p:nvPr/>
        </p:nvSpPr>
        <p:spPr>
          <a:xfrm>
            <a:off x="1238435" y="1016419"/>
            <a:ext cx="4337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0736BD6-E828-4619-BEAD-DA05F87E20A4}"/>
              </a:ext>
            </a:extLst>
          </p:cNvPr>
          <p:cNvSpPr txBox="1"/>
          <p:nvPr/>
        </p:nvSpPr>
        <p:spPr>
          <a:xfrm>
            <a:off x="1238400" y="3484001"/>
            <a:ext cx="4337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CA098FF3-27B9-4C0E-9114-9050C95478D8}"/>
              </a:ext>
            </a:extLst>
          </p:cNvPr>
          <p:cNvSpPr/>
          <p:nvPr/>
        </p:nvSpPr>
        <p:spPr>
          <a:xfrm>
            <a:off x="1128879" y="6301146"/>
            <a:ext cx="495633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S.2.Biological process of differentially expressed proteins in A/C. </a:t>
            </a:r>
            <a:r>
              <a:rPr lang="en-US" altLang="zh-CN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Biological process of up-regulated proteins in A/C. (B) Biological process of down-regulated proteins in A/C.</a:t>
            </a:r>
            <a:endParaRPr lang="zh-CN" altLang="zh-CN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44112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组合 9">
            <a:extLst>
              <a:ext uri="{FF2B5EF4-FFF2-40B4-BE49-F238E27FC236}">
                <a16:creationId xmlns:a16="http://schemas.microsoft.com/office/drawing/2014/main" id="{AF4B61E6-8FEE-4AE7-8B1A-11CCFF3EBC65}"/>
              </a:ext>
            </a:extLst>
          </p:cNvPr>
          <p:cNvGrpSpPr/>
          <p:nvPr/>
        </p:nvGrpSpPr>
        <p:grpSpPr>
          <a:xfrm>
            <a:off x="1684659" y="1158407"/>
            <a:ext cx="3734175" cy="4990144"/>
            <a:chOff x="1743216" y="2789012"/>
            <a:chExt cx="3734175" cy="4990144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AE267402-60F9-4061-9ADF-7A6016D2F4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7974" t="2011" r="10180" b="8235"/>
            <a:stretch/>
          </p:blipFill>
          <p:spPr>
            <a:xfrm>
              <a:off x="2360322" y="2951156"/>
              <a:ext cx="3117069" cy="2324288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CF6F0940-6ACA-48A7-8741-9942527C76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5194" t="793" r="11431" b="8061"/>
            <a:stretch/>
          </p:blipFill>
          <p:spPr>
            <a:xfrm>
              <a:off x="1743216" y="5418833"/>
              <a:ext cx="3698140" cy="2360323"/>
            </a:xfrm>
            <a:prstGeom prst="rect">
              <a:avLst/>
            </a:prstGeom>
          </p:spPr>
        </p:pic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32D43C69-253D-4BA7-B1C5-545C53E7979B}"/>
                </a:ext>
              </a:extLst>
            </p:cNvPr>
            <p:cNvSpPr txBox="1"/>
            <p:nvPr/>
          </p:nvSpPr>
          <p:spPr>
            <a:xfrm>
              <a:off x="2835341" y="2789012"/>
              <a:ext cx="13494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p regulated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45660710-E038-4E57-AF70-A8FDC6D9BBEE}"/>
                </a:ext>
              </a:extLst>
            </p:cNvPr>
            <p:cNvSpPr txBox="1"/>
            <p:nvPr/>
          </p:nvSpPr>
          <p:spPr>
            <a:xfrm>
              <a:off x="2800432" y="5292708"/>
              <a:ext cx="13494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own regulated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" name="文本框 8">
            <a:extLst>
              <a:ext uri="{FF2B5EF4-FFF2-40B4-BE49-F238E27FC236}">
                <a16:creationId xmlns:a16="http://schemas.microsoft.com/office/drawing/2014/main" id="{0D2189EF-32CA-447C-97A3-CC3BD0FC3319}"/>
              </a:ext>
            </a:extLst>
          </p:cNvPr>
          <p:cNvSpPr txBox="1"/>
          <p:nvPr/>
        </p:nvSpPr>
        <p:spPr>
          <a:xfrm>
            <a:off x="2534477" y="610552"/>
            <a:ext cx="17890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FigS.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F45C2BB2-B355-48EE-ADBD-9C97ADA66DDF}"/>
              </a:ext>
            </a:extLst>
          </p:cNvPr>
          <p:cNvSpPr txBox="1"/>
          <p:nvPr/>
        </p:nvSpPr>
        <p:spPr>
          <a:xfrm>
            <a:off x="1403806" y="1113699"/>
            <a:ext cx="4337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5EBE6611-DC99-410B-854B-C225A8B464DC}"/>
              </a:ext>
            </a:extLst>
          </p:cNvPr>
          <p:cNvSpPr txBox="1"/>
          <p:nvPr/>
        </p:nvSpPr>
        <p:spPr>
          <a:xfrm>
            <a:off x="1403809" y="3603985"/>
            <a:ext cx="4337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CAAD2965-37DF-4303-9DDA-9F4DDD88FB9F}"/>
              </a:ext>
            </a:extLst>
          </p:cNvPr>
          <p:cNvSpPr/>
          <p:nvPr/>
        </p:nvSpPr>
        <p:spPr>
          <a:xfrm>
            <a:off x="1402480" y="6438711"/>
            <a:ext cx="4537073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S.3.Biological process of differentially expressed proteins in B/C. </a:t>
            </a:r>
            <a:r>
              <a:rPr lang="en-US" altLang="zh-CN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Biological process of up-regulated proteins in B/C. (B) Biological process of down-regulated proteins in B/C.</a:t>
            </a:r>
            <a:endParaRPr lang="zh-CN" altLang="zh-CN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81131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88</Words>
  <Application>Microsoft Office PowerPoint</Application>
  <PresentationFormat>A4 纸张(210x297 毫米)</PresentationFormat>
  <Paragraphs>24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韩霄</dc:creator>
  <cp:lastModifiedBy>xiao han</cp:lastModifiedBy>
  <cp:revision>76</cp:revision>
  <dcterms:created xsi:type="dcterms:W3CDTF">2018-03-09T06:45:30Z</dcterms:created>
  <dcterms:modified xsi:type="dcterms:W3CDTF">2019-07-14T06:43:03Z</dcterms:modified>
</cp:coreProperties>
</file>